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819" y="69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8903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18505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05265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6298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9992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54772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66821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98469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94368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38188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9846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9FE76A-4722-4A48-9C76-F9CD655AC6D4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00232-C024-468D-B46E-6F8B577E92A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3345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0" y="0"/>
            <a:ext cx="24240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2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458780" y="4268433"/>
            <a:ext cx="90678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Regional plots depicting associations of (A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C01197 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TR1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/rs1994147, (B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WTR1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s6802474_rs11925206_rs6783721, (C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FAP95 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9orf135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/rs10780705_rs11140930, (D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1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s12682151, (E) rs58352046/rs76053630/rs602988136, (F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U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hr4:127564977_G_GT, (G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3K7CL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s57220716, (H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DC2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s10511980, (I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ZW1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K1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s2881881_rs6735908, and (J)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C01894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s1786166). Y-axis shows -log</a:t>
            </a:r>
            <a:r>
              <a:rPr lang="en-US" altLang="zh-TW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of the SNPs, x-axis shows the chromosomal position of each SNP. The genomic positions of genes within these regions were annotated using the UCSC Genome Browser. The linkage disequilibrium (LD r</a:t>
            </a:r>
            <a:r>
              <a:rPr lang="en-US" altLang="zh-TW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s shown by colors coding across the range of r</a:t>
            </a:r>
            <a:r>
              <a:rPr lang="en-US" altLang="zh-TW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gray triangle denotes that the LD r</a:t>
            </a:r>
            <a:r>
              <a:rPr lang="en-US" altLang="zh-TW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marked SNP with the reference SNP is 0.</a:t>
            </a:r>
            <a:endParaRPr lang="zh-TW" altLang="zh-TW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B2D523F9-C749-1EB7-1E33-9DB356408298}"/>
              </a:ext>
            </a:extLst>
          </p:cNvPr>
          <p:cNvSpPr txBox="1"/>
          <p:nvPr/>
        </p:nvSpPr>
        <p:spPr>
          <a:xfrm>
            <a:off x="0" y="926703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A)</a:t>
            </a:r>
            <a:endParaRPr lang="zh-TW" altLang="en-US" dirty="0"/>
          </a:p>
        </p:txBody>
      </p:sp>
      <p:pic>
        <p:nvPicPr>
          <p:cNvPr id="3" name="圖片 2" descr="一張含有 文字, 螢幕擷取畫面, 行, 繪圖 的圖片&#10;&#10;自動產生的描述">
            <a:extLst>
              <a:ext uri="{FF2B5EF4-FFF2-40B4-BE49-F238E27FC236}">
                <a16:creationId xmlns:a16="http://schemas.microsoft.com/office/drawing/2014/main" id="{D646CBDB-9D2D-FD5C-C254-8182A0370CF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454"/>
          <a:stretch/>
        </p:blipFill>
        <p:spPr>
          <a:xfrm>
            <a:off x="0" y="1366374"/>
            <a:ext cx="9906000" cy="2598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02414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2E618A87-6419-9762-58B1-A865100D547E}"/>
              </a:ext>
            </a:extLst>
          </p:cNvPr>
          <p:cNvSpPr txBox="1"/>
          <p:nvPr/>
        </p:nvSpPr>
        <p:spPr>
          <a:xfrm>
            <a:off x="0" y="0"/>
            <a:ext cx="3337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2, continued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2CEFA710-051D-A800-C24F-D2CEBDF1EC58}"/>
              </a:ext>
            </a:extLst>
          </p:cNvPr>
          <p:cNvSpPr txBox="1"/>
          <p:nvPr/>
        </p:nvSpPr>
        <p:spPr>
          <a:xfrm>
            <a:off x="0" y="659368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B)</a:t>
            </a:r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A618B240-CC16-7A76-A196-65CCF589B11F}"/>
              </a:ext>
            </a:extLst>
          </p:cNvPr>
          <p:cNvSpPr txBox="1"/>
          <p:nvPr/>
        </p:nvSpPr>
        <p:spPr>
          <a:xfrm>
            <a:off x="0" y="3686853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C)</a:t>
            </a:r>
            <a:endParaRPr lang="zh-TW" altLang="en-US" dirty="0"/>
          </a:p>
        </p:txBody>
      </p:sp>
      <p:pic>
        <p:nvPicPr>
          <p:cNvPr id="6" name="圖片 5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9B47AF2F-7E0B-1B30-A995-C5CDABE5E5C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127"/>
          <a:stretch/>
        </p:blipFill>
        <p:spPr>
          <a:xfrm>
            <a:off x="0" y="1119844"/>
            <a:ext cx="9906000" cy="2475865"/>
          </a:xfrm>
          <a:prstGeom prst="rect">
            <a:avLst/>
          </a:prstGeom>
        </p:spPr>
      </p:pic>
      <p:pic>
        <p:nvPicPr>
          <p:cNvPr id="10" name="圖片 9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35E44A56-036C-D136-C42E-2DE98D0BDC2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287"/>
          <a:stretch/>
        </p:blipFill>
        <p:spPr>
          <a:xfrm>
            <a:off x="0" y="4147329"/>
            <a:ext cx="9906000" cy="2302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31313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8C9F3FF1-7A06-EFCB-7CEC-1C7B96326982}"/>
              </a:ext>
            </a:extLst>
          </p:cNvPr>
          <p:cNvSpPr txBox="1"/>
          <p:nvPr/>
        </p:nvSpPr>
        <p:spPr>
          <a:xfrm>
            <a:off x="0" y="0"/>
            <a:ext cx="3337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2, continued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D4A3F5C6-3300-FB6F-4973-D56047E48561}"/>
              </a:ext>
            </a:extLst>
          </p:cNvPr>
          <p:cNvSpPr txBox="1"/>
          <p:nvPr/>
        </p:nvSpPr>
        <p:spPr>
          <a:xfrm>
            <a:off x="0" y="659368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D)</a:t>
            </a:r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B15731C6-19C8-FBA0-D4AE-543BD43BB1C3}"/>
              </a:ext>
            </a:extLst>
          </p:cNvPr>
          <p:cNvSpPr txBox="1"/>
          <p:nvPr/>
        </p:nvSpPr>
        <p:spPr>
          <a:xfrm>
            <a:off x="0" y="3686853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E)</a:t>
            </a:r>
            <a:endParaRPr lang="zh-TW" altLang="en-US" dirty="0"/>
          </a:p>
        </p:txBody>
      </p:sp>
      <p:pic>
        <p:nvPicPr>
          <p:cNvPr id="6" name="圖片 5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EB5D7BFE-718B-353F-B90A-2567AAC56F3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358"/>
          <a:stretch/>
        </p:blipFill>
        <p:spPr>
          <a:xfrm>
            <a:off x="0" y="1225693"/>
            <a:ext cx="9906000" cy="2132965"/>
          </a:xfrm>
          <a:prstGeom prst="rect">
            <a:avLst/>
          </a:prstGeom>
        </p:spPr>
      </p:pic>
      <p:pic>
        <p:nvPicPr>
          <p:cNvPr id="8" name="圖片 7" descr="一張含有 文字, 行, 繪圖, 螢幕擷取畫面 的圖片&#10;&#10;自動產生的描述">
            <a:extLst>
              <a:ext uri="{FF2B5EF4-FFF2-40B4-BE49-F238E27FC236}">
                <a16:creationId xmlns:a16="http://schemas.microsoft.com/office/drawing/2014/main" id="{7A31CB83-3D9B-1934-79EE-A727A6D9526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358"/>
          <a:stretch/>
        </p:blipFill>
        <p:spPr>
          <a:xfrm>
            <a:off x="0" y="4384380"/>
            <a:ext cx="9906000" cy="21329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7235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B90886-97E5-B953-933E-0A788ACCB2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573D5C34-5BA2-4910-FED2-9014B8211352}"/>
              </a:ext>
            </a:extLst>
          </p:cNvPr>
          <p:cNvSpPr txBox="1"/>
          <p:nvPr/>
        </p:nvSpPr>
        <p:spPr>
          <a:xfrm>
            <a:off x="0" y="0"/>
            <a:ext cx="3337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2, continued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38957184-5E2B-DB27-6CE1-1CCD9990BB31}"/>
              </a:ext>
            </a:extLst>
          </p:cNvPr>
          <p:cNvSpPr txBox="1"/>
          <p:nvPr/>
        </p:nvSpPr>
        <p:spPr>
          <a:xfrm>
            <a:off x="0" y="659368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F)</a:t>
            </a:r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EC276A79-DBC0-95F7-7002-12DAD9571802}"/>
              </a:ext>
            </a:extLst>
          </p:cNvPr>
          <p:cNvSpPr txBox="1"/>
          <p:nvPr/>
        </p:nvSpPr>
        <p:spPr>
          <a:xfrm>
            <a:off x="0" y="3686853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G)</a:t>
            </a:r>
            <a:endParaRPr lang="zh-TW" altLang="en-US" dirty="0"/>
          </a:p>
        </p:txBody>
      </p:sp>
      <p:pic>
        <p:nvPicPr>
          <p:cNvPr id="8" name="圖片 7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88810C26-0FDB-FCCD-90F6-4B6FEBEB29D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962"/>
          <a:stretch/>
        </p:blipFill>
        <p:spPr>
          <a:xfrm>
            <a:off x="0" y="1155303"/>
            <a:ext cx="9906000" cy="2414374"/>
          </a:xfrm>
          <a:prstGeom prst="rect">
            <a:avLst/>
          </a:prstGeom>
        </p:spPr>
      </p:pic>
      <p:pic>
        <p:nvPicPr>
          <p:cNvPr id="6" name="圖片 5" descr="一張含有 文字, 行, 繪圖, 螢幕擷取畫面 的圖片&#10;&#10;自動產生的描述">
            <a:extLst>
              <a:ext uri="{FF2B5EF4-FFF2-40B4-BE49-F238E27FC236}">
                <a16:creationId xmlns:a16="http://schemas.microsoft.com/office/drawing/2014/main" id="{99EC9E91-A118-F06F-A69C-619D2A7A89C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962"/>
          <a:stretch/>
        </p:blipFill>
        <p:spPr>
          <a:xfrm>
            <a:off x="0" y="4173361"/>
            <a:ext cx="9906000" cy="2414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49965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2E1F562-1FCC-E411-B63B-0DD459A989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22DEC047-342E-42BB-073B-B52951C60DF3}"/>
              </a:ext>
            </a:extLst>
          </p:cNvPr>
          <p:cNvSpPr txBox="1"/>
          <p:nvPr/>
        </p:nvSpPr>
        <p:spPr>
          <a:xfrm>
            <a:off x="0" y="0"/>
            <a:ext cx="3337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2, continued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6EF1426F-2FF9-9D1C-1F8E-A16FA394FA49}"/>
              </a:ext>
            </a:extLst>
          </p:cNvPr>
          <p:cNvSpPr txBox="1"/>
          <p:nvPr/>
        </p:nvSpPr>
        <p:spPr>
          <a:xfrm>
            <a:off x="0" y="659368"/>
            <a:ext cx="470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H)</a:t>
            </a:r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8CB07148-E30D-9848-26ED-0B45D0529A44}"/>
              </a:ext>
            </a:extLst>
          </p:cNvPr>
          <p:cNvSpPr txBox="1"/>
          <p:nvPr/>
        </p:nvSpPr>
        <p:spPr>
          <a:xfrm>
            <a:off x="0" y="3686853"/>
            <a:ext cx="38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I)</a:t>
            </a:r>
            <a:endParaRPr lang="zh-TW" altLang="en-US" dirty="0"/>
          </a:p>
        </p:txBody>
      </p:sp>
      <p:pic>
        <p:nvPicPr>
          <p:cNvPr id="6" name="圖片 5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40577C1A-997E-7B56-0469-C27BFD5B6B6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998"/>
          <a:stretch/>
        </p:blipFill>
        <p:spPr>
          <a:xfrm>
            <a:off x="0" y="1216902"/>
            <a:ext cx="9906000" cy="2212096"/>
          </a:xfrm>
          <a:prstGeom prst="rect">
            <a:avLst/>
          </a:prstGeom>
        </p:spPr>
      </p:pic>
      <p:pic>
        <p:nvPicPr>
          <p:cNvPr id="10" name="圖片 9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54239A0B-9488-F655-FA8B-58CD99ED4AA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998"/>
          <a:stretch/>
        </p:blipFill>
        <p:spPr>
          <a:xfrm>
            <a:off x="0" y="4314040"/>
            <a:ext cx="9906000" cy="2212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06732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3E80F6B9-5CE0-69F3-1A97-C2218FAF3D3E}"/>
              </a:ext>
            </a:extLst>
          </p:cNvPr>
          <p:cNvSpPr txBox="1"/>
          <p:nvPr/>
        </p:nvSpPr>
        <p:spPr>
          <a:xfrm>
            <a:off x="0" y="0"/>
            <a:ext cx="3337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2, continued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1290270B-E57B-C8CD-0101-953B26D0193C}"/>
              </a:ext>
            </a:extLst>
          </p:cNvPr>
          <p:cNvSpPr txBox="1"/>
          <p:nvPr/>
        </p:nvSpPr>
        <p:spPr>
          <a:xfrm>
            <a:off x="0" y="659368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J)</a:t>
            </a:r>
            <a:endParaRPr lang="zh-TW" altLang="en-US" dirty="0"/>
          </a:p>
        </p:txBody>
      </p:sp>
      <p:pic>
        <p:nvPicPr>
          <p:cNvPr id="5" name="圖片 4" descr="一張含有 文字, 行, 繪圖, 字型 的圖片&#10;&#10;自動產生的描述">
            <a:extLst>
              <a:ext uri="{FF2B5EF4-FFF2-40B4-BE49-F238E27FC236}">
                <a16:creationId xmlns:a16="http://schemas.microsoft.com/office/drawing/2014/main" id="{F238EF83-8DA1-8556-3118-80BD468ECE6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995"/>
          <a:stretch/>
        </p:blipFill>
        <p:spPr>
          <a:xfrm>
            <a:off x="0" y="1243281"/>
            <a:ext cx="9906000" cy="2748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5334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主題">
  <a:themeElements>
    <a:clrScheme name="Office 2013 - 2022 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2</TotalTime>
  <Words>241</Words>
  <Application>Microsoft Office PowerPoint</Application>
  <PresentationFormat>A4 紙張 (210x297 公釐)</PresentationFormat>
  <Paragraphs>17</Paragraphs>
  <Slides>6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2013 - 2022 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>WEIGER_B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ei-De Lin</dc:creator>
  <cp:lastModifiedBy>瑋德 林</cp:lastModifiedBy>
  <cp:revision>16</cp:revision>
  <dcterms:created xsi:type="dcterms:W3CDTF">2023-05-24T07:58:16Z</dcterms:created>
  <dcterms:modified xsi:type="dcterms:W3CDTF">2024-03-10T05:46:02Z</dcterms:modified>
</cp:coreProperties>
</file>